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danzQC-JF" initials="JF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60" y="8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CE91D1-E404-4EAB-9FB6-C6531D0D406C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39775"/>
            <a:ext cx="2773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8936C8-C058-4491-BDDA-56099C80B6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67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8936C8-C058-4491-BDDA-56099C80B65E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8142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5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100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6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438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886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342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429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6643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205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582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753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416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"/>
          <p:cNvPicPr>
            <a:picLocks noChangeAspect="1" noChangeArrowheads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1226"/>
          <a:stretch/>
        </p:blipFill>
        <p:spPr bwMode="auto">
          <a:xfrm>
            <a:off x="872716" y="3136598"/>
            <a:ext cx="5112568" cy="5611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テキスト ボックス 26"/>
          <p:cNvSpPr txBox="1"/>
          <p:nvPr/>
        </p:nvSpPr>
        <p:spPr>
          <a:xfrm>
            <a:off x="-8704" y="1546"/>
            <a:ext cx="23038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0" y="827584"/>
            <a:ext cx="6858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 - The RNA expression of </a:t>
            </a:r>
            <a:r>
              <a:rPr lang="en-US" altLang="ja-JP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mS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ngivalis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277, PGN_1740 mutant and complemented mutant strain.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RNA extracted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wild-type 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ngivalis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3277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the PGN_1740 mutant and complemented mutant strain in planktonic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nalyzed by real-time PCR. 16s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used for normalization. The data shown are mean ± SD of triplicate experiments. 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5271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5</TotalTime>
  <Words>12</Words>
  <Application>Microsoft Office PowerPoint</Application>
  <PresentationFormat>画面に合わせる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菊池有一郎</dc:creator>
  <cp:lastModifiedBy>菊池有一郎</cp:lastModifiedBy>
  <cp:revision>49</cp:revision>
  <cp:lastPrinted>2014-11-25T09:31:52Z</cp:lastPrinted>
  <dcterms:created xsi:type="dcterms:W3CDTF">2014-12-22T02:55:55Z</dcterms:created>
  <dcterms:modified xsi:type="dcterms:W3CDTF">2015-01-05T01:49:45Z</dcterms:modified>
</cp:coreProperties>
</file>